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9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31" autoAdjust="0"/>
    <p:restoredTop sz="94660"/>
  </p:normalViewPr>
  <p:slideViewPr>
    <p:cSldViewPr snapToGrid="0">
      <p:cViewPr varScale="1">
        <p:scale>
          <a:sx n="91" d="100"/>
          <a:sy n="91" d="100"/>
        </p:scale>
        <p:origin x="8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13ED85-E660-412D-B147-63145FA7661F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99A030-C10B-4881-BC0B-628BF3EE7C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3325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1">
                <a:solidFill>
                  <a:srgbClr val="3331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S7: Ingenuity Pathway Analysis (IPA) network legends, shapes, and edge descriptions</a:t>
            </a:r>
            <a:endParaRPr lang="en-US" sz="18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C99A030-C10B-4881-BC0B-628BF3EE7CE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2345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BA1F22-3E49-5CA4-F11D-AB80911E340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584915D-8648-024C-019E-E68C8F43F7B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CE0757-8826-4D51-6E9E-4A557A10CD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31B69-8F2B-42BB-A19C-5D19D302B680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A20945-F389-9AAD-7C02-B081A2368E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E32437-7E70-47CC-7F06-4F8880714A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5D0B9-B60B-47F9-BAC9-198E2E1FF6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3861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DF2931-503A-12EC-598F-A455EBBD96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F1453A-6A9E-1E69-CBBE-E798A27F38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A8FB19-57B8-A0B5-E53E-71C2083E51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31B69-8F2B-42BB-A19C-5D19D302B680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D6142D-51AC-EC56-79B6-77C0EE2D6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DD88F1-527E-5FE2-0645-11E93494B4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5D0B9-B60B-47F9-BAC9-198E2E1FF6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978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07868AC-1DA0-EA3A-0DCA-14B113A420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8631D0-394D-AA85-5C75-F957FCD8B4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15EFCE-7A57-809F-2FED-4FDE576434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31B69-8F2B-42BB-A19C-5D19D302B680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61012E-1D04-0E13-621B-AFEA034FA1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752B15-FD84-E10D-03AC-E76986651E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5D0B9-B60B-47F9-BAC9-198E2E1FF6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58112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929F20-1A80-9E78-D2EE-8631510284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907317-E3F8-15C6-8027-EC02C3E0EC6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9F847F-CA35-DBFB-15FD-9BF3654159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31B69-8F2B-42BB-A19C-5D19D302B680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826A99-C017-638F-C707-B712400557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BF0DC0-C764-D726-EC5B-4B199DBC2B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5D0B9-B60B-47F9-BAC9-198E2E1FF6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9227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7DB02E-B304-E562-75C6-7B1F1E3F3C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589AAE-3C36-D838-3D46-067585567F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337AA0-910C-2AB0-572D-598EB68F6C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31B69-8F2B-42BB-A19C-5D19D302B680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0B26A0-9E49-42C8-1A59-3182F9E484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BCE91B-0142-3BE7-AC44-7B091A179F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5D0B9-B60B-47F9-BAC9-198E2E1FF6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04306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913021-31C3-F4DF-18FC-F7FC88F67D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2403D0-EC56-3D93-03D6-907ED65AF0F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BC3A1C-5252-F12F-A54A-B6257A8262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4A8841-8A6C-50CC-DFB9-5B4AB85E5D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31B69-8F2B-42BB-A19C-5D19D302B680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B789EC-E274-E348-F6CF-60B74532CC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9C4473-5182-EE72-2E9F-E056E42E25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5D0B9-B60B-47F9-BAC9-198E2E1FF6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11196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873035-A555-2360-A03E-BEDA9AF481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D49F09-6BF3-D9F6-AE59-57A92A9683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B88558-D7E7-2146-CA3C-67F2F6640B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0D93A18-20F7-52F1-A0FC-82E4CAD7A1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3C3BA09-1126-437E-C335-C739047BA27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8AA51CF-5783-B35C-326B-930A80C9E8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31B69-8F2B-42BB-A19C-5D19D302B680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660A463-B763-1D24-B2FD-E7D54AA9EF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ED6B837-AE9A-2464-B7B8-B5CD3E00FC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5D0B9-B60B-47F9-BAC9-198E2E1FF6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01978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8EE56C-D1E7-0005-406D-C499BE1AF9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363B3E7-A28D-E7CC-4221-868F404E10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31B69-8F2B-42BB-A19C-5D19D302B680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99E20F2-31EC-25CF-27D5-B78895DB1B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3018606-5371-8E3D-8578-57709D66ED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5D0B9-B60B-47F9-BAC9-198E2E1FF6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6110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64E534E-6866-37CA-D8A0-FD6C625DCB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31B69-8F2B-42BB-A19C-5D19D302B680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7D93F11-A75E-E979-9908-749C3F6966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288B3D1-9A05-0876-6353-F4554985BE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5D0B9-B60B-47F9-BAC9-198E2E1FF6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3992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33C0B4-A320-8131-BBDA-9CEF0C331E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AE9B88-73F4-CE2C-E333-32E72972EF2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98C5C9-971C-9955-7B77-B7AFCE5E82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3B2C53-C1FB-0117-E37F-05BE069BAD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31B69-8F2B-42BB-A19C-5D19D302B680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E0EFB1-3EE7-6905-C495-4E8CC47330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9655D9-E9D2-E8F4-E51B-C19522CF5E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5D0B9-B60B-47F9-BAC9-198E2E1FF6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47962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A6E7B9-58CB-9CD0-407E-2D1618D847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B856DBB-38C6-E360-8F32-81E588D3C3E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BC3C86A-BBE6-9CD4-9131-68E5116DE9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F3FE2B-759F-91F8-0148-0FF617E141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31B69-8F2B-42BB-A19C-5D19D302B680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5BE7F50-D0B5-11A2-136A-38C95A7B49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5CCB6D-05E0-E5D8-E5B9-1D4203C144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5D0B9-B60B-47F9-BAC9-198E2E1FF6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264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C62EF44-CF5F-2C72-0C8A-56C5B0499E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4CBF5A-6BD2-78A4-4376-CE2453D68A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847347-CF31-2C5E-90DA-4AF55ED820D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231B69-8F2B-42BB-A19C-5D19D302B680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56A989-13DE-5DDA-0D88-80879D543A5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C5F342-BF66-93B6-488F-FA1C121C8C2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95D0B9-B60B-47F9-BAC9-198E2E1FF6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0227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45196EB-6FA7-B85C-407F-9C099E99FB1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952" t="1731" r="2672" b="959"/>
          <a:stretch/>
        </p:blipFill>
        <p:spPr>
          <a:xfrm>
            <a:off x="210043" y="1737086"/>
            <a:ext cx="2149190" cy="356223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4C32FAB-2CA3-2EDF-9C73-32E14BB306B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25972" y="800140"/>
            <a:ext cx="4032497" cy="580016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A74768D-18C3-BF44-EBFB-A809ECFBB0D0}"/>
              </a:ext>
            </a:extLst>
          </p:cNvPr>
          <p:cNvSpPr txBox="1"/>
          <p:nvPr/>
        </p:nvSpPr>
        <p:spPr>
          <a:xfrm>
            <a:off x="1978228" y="198518"/>
            <a:ext cx="93666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Ingenuity Pathway Analysis (IPA) Network Legends, Shapes, and Edge Description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FD04D86-4B24-8052-0962-B48BFFB0A518}"/>
              </a:ext>
            </a:extLst>
          </p:cNvPr>
          <p:cNvSpPr txBox="1"/>
          <p:nvPr/>
        </p:nvSpPr>
        <p:spPr>
          <a:xfrm>
            <a:off x="0" y="127049"/>
            <a:ext cx="19447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 S7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B4D6058-E1D7-5FA0-6A44-4451DE5E7ED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916" r="10349"/>
          <a:stretch/>
        </p:blipFill>
        <p:spPr>
          <a:xfrm>
            <a:off x="7158469" y="854110"/>
            <a:ext cx="3274400" cy="58390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2040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9</TotalTime>
  <Words>36</Words>
  <Application>Microsoft Office PowerPoint</Application>
  <PresentationFormat>Widescreen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Graner</dc:creator>
  <cp:lastModifiedBy>Michael Graner</cp:lastModifiedBy>
  <cp:revision>5</cp:revision>
  <dcterms:created xsi:type="dcterms:W3CDTF">2022-12-23T16:23:08Z</dcterms:created>
  <dcterms:modified xsi:type="dcterms:W3CDTF">2023-03-14T21:45:19Z</dcterms:modified>
</cp:coreProperties>
</file>